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0" r:id="rId5"/>
    <p:sldId id="267" r:id="rId6"/>
    <p:sldId id="268" r:id="rId7"/>
    <p:sldId id="269" r:id="rId8"/>
    <p:sldId id="266" r:id="rId9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2" d="100"/>
          <a:sy n="72" d="100"/>
        </p:scale>
        <p:origin x="62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Breeding%20paper\MS\Starch_GE\MS_ST_ANL\Heritability_by_Environmen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[1]Sheet1!$A$1:$J$1</c:f>
              <c:strCache>
                <c:ptCount val="10"/>
                <c:pt idx="0">
                  <c:v>RDS</c:v>
                </c:pt>
                <c:pt idx="1">
                  <c:v>SDS</c:v>
                </c:pt>
                <c:pt idx="2">
                  <c:v>RS</c:v>
                </c:pt>
                <c:pt idx="3">
                  <c:v>TS</c:v>
                </c:pt>
                <c:pt idx="4">
                  <c:v>DF50</c:v>
                </c:pt>
                <c:pt idx="5">
                  <c:v>PH</c:v>
                </c:pt>
                <c:pt idx="6">
                  <c:v>GY</c:v>
                </c:pt>
                <c:pt idx="7">
                  <c:v>PL</c:v>
                </c:pt>
                <c:pt idx="8">
                  <c:v>Fe</c:v>
                </c:pt>
                <c:pt idx="9">
                  <c:v>Zn</c:v>
                </c:pt>
              </c:strCache>
            </c:strRef>
          </c:cat>
          <c:val>
            <c:numRef>
              <c:f>[1]Sheet1!$A$2:$J$2</c:f>
              <c:numCache>
                <c:formatCode>General</c:formatCode>
                <c:ptCount val="10"/>
                <c:pt idx="0">
                  <c:v>0.73044606449222904</c:v>
                </c:pt>
                <c:pt idx="1">
                  <c:v>0.61265452385402797</c:v>
                </c:pt>
                <c:pt idx="2">
                  <c:v>0.78846548288831098</c:v>
                </c:pt>
                <c:pt idx="3">
                  <c:v>0.71422191813525504</c:v>
                </c:pt>
                <c:pt idx="4">
                  <c:v>0.75297212295455196</c:v>
                </c:pt>
                <c:pt idx="5">
                  <c:v>0.84582474924720596</c:v>
                </c:pt>
                <c:pt idx="6">
                  <c:v>0.71618128987315699</c:v>
                </c:pt>
                <c:pt idx="7">
                  <c:v>0.952087710152696</c:v>
                </c:pt>
                <c:pt idx="8">
                  <c:v>0.91196392952344396</c:v>
                </c:pt>
                <c:pt idx="9">
                  <c:v>0.728872551644315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4F-433C-9015-1AEFFF8CA9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80353264"/>
        <c:axId val="980352936"/>
      </c:barChart>
      <c:catAx>
        <c:axId val="9803532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rai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0352936"/>
        <c:crosses val="autoZero"/>
        <c:auto val="1"/>
        <c:lblAlgn val="ctr"/>
        <c:lblOffset val="100"/>
        <c:noMultiLvlLbl val="0"/>
      </c:catAx>
      <c:valAx>
        <c:axId val="9803529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Heretibilit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0353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7356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9324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3108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6296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1862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9527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6718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1248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4673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6440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9860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D33824-AFB7-4320-8484-43802C948D4A}" type="datetimeFigureOut">
              <a:rPr lang="en-GB" smtClean="0"/>
              <a:t>06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EAD550-B377-445C-8EAA-15677FF5F4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7676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7" Type="http://schemas.microsoft.com/office/2007/relationships/hdphoto" Target="../media/hdphoto4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microsoft.com/office/2007/relationships/hdphoto" Target="../media/hdphoto3.wdp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7" Type="http://schemas.microsoft.com/office/2007/relationships/hdphoto" Target="../media/hdphoto7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microsoft.com/office/2007/relationships/hdphoto" Target="../media/hdphoto6.wdp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ACBEB021-BFC7-4B57-A4DB-49A6721835F3}"/>
              </a:ext>
            </a:extLst>
          </p:cNvPr>
          <p:cNvSpPr txBox="1"/>
          <p:nvPr/>
        </p:nvSpPr>
        <p:spPr>
          <a:xfrm>
            <a:off x="895739" y="5920853"/>
            <a:ext cx="25379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0" i="0" u="none" strike="noStrike" baseline="0" dirty="0">
                <a:latin typeface="LMRoman10-Regular"/>
              </a:rPr>
              <a:t>Supplementary Figure S1</a:t>
            </a:r>
            <a:endParaRPr lang="en-GB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018C9D1-F237-4FFD-88FF-A5745CEA58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81034"/>
            <a:ext cx="9144000" cy="16959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50062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Chart, bar chart&#10;&#10;Description automatically generated">
            <a:extLst>
              <a:ext uri="{FF2B5EF4-FFF2-40B4-BE49-F238E27FC236}">
                <a16:creationId xmlns:a16="http://schemas.microsoft.com/office/drawing/2014/main" id="{12E29C71-DFDC-E0EF-3711-C816007A9D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270" y="360287"/>
            <a:ext cx="3930266" cy="2634839"/>
          </a:xfrm>
          <a:prstGeom prst="rect">
            <a:avLst/>
          </a:prstGeom>
        </p:spPr>
      </p:pic>
      <p:pic>
        <p:nvPicPr>
          <p:cNvPr id="10" name="Picture 9" descr="Chart, bar chart&#10;&#10;Description automatically generated">
            <a:extLst>
              <a:ext uri="{FF2B5EF4-FFF2-40B4-BE49-F238E27FC236}">
                <a16:creationId xmlns:a16="http://schemas.microsoft.com/office/drawing/2014/main" id="{B88399C3-33AB-B7B6-CCB1-A30516C02EA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1999" y="322966"/>
            <a:ext cx="4300257" cy="2634839"/>
          </a:xfrm>
          <a:prstGeom prst="rect">
            <a:avLst/>
          </a:prstGeom>
        </p:spPr>
      </p:pic>
      <p:pic>
        <p:nvPicPr>
          <p:cNvPr id="12" name="Picture 11" descr="Chart, bar chart&#10;&#10;Description automatically generated">
            <a:extLst>
              <a:ext uri="{FF2B5EF4-FFF2-40B4-BE49-F238E27FC236}">
                <a16:creationId xmlns:a16="http://schemas.microsoft.com/office/drawing/2014/main" id="{8FA90CDD-B7DD-0AD8-CA12-969A74BFF67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4409" y="3078290"/>
            <a:ext cx="4580357" cy="275153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ADB570C-4F73-AEAC-A167-5134F14AB856}"/>
              </a:ext>
            </a:extLst>
          </p:cNvPr>
          <p:cNvSpPr txBox="1"/>
          <p:nvPr/>
        </p:nvSpPr>
        <p:spPr>
          <a:xfrm>
            <a:off x="354563" y="6313047"/>
            <a:ext cx="336835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0" i="0" u="none" strike="noStrike" baseline="0" dirty="0">
                <a:latin typeface="LMRoman10-Regular"/>
              </a:rPr>
              <a:t>Supplementary Figure S2a, b, c</a:t>
            </a:r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BA3A7D6-4D93-7C0B-4914-51660A9A4FF0}"/>
              </a:ext>
            </a:extLst>
          </p:cNvPr>
          <p:cNvSpPr txBox="1"/>
          <p:nvPr/>
        </p:nvSpPr>
        <p:spPr>
          <a:xfrm>
            <a:off x="564807" y="2625794"/>
            <a:ext cx="5505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5FFA382-8EBA-747E-8B07-16F578761444}"/>
              </a:ext>
            </a:extLst>
          </p:cNvPr>
          <p:cNvSpPr txBox="1"/>
          <p:nvPr/>
        </p:nvSpPr>
        <p:spPr>
          <a:xfrm>
            <a:off x="4571999" y="2611730"/>
            <a:ext cx="5505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29AB302-6A25-4BCB-D2F9-3C6DBA533A37}"/>
              </a:ext>
            </a:extLst>
          </p:cNvPr>
          <p:cNvSpPr txBox="1"/>
          <p:nvPr/>
        </p:nvSpPr>
        <p:spPr>
          <a:xfrm>
            <a:off x="2404409" y="5466744"/>
            <a:ext cx="5505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2679263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F58F71E-2E6D-DCE5-D430-BDA7BEFBDF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570" y="0"/>
            <a:ext cx="4623745" cy="2292514"/>
          </a:xfrm>
          <a:prstGeom prst="rect">
            <a:avLst/>
          </a:prstGeom>
        </p:spPr>
      </p:pic>
      <p:pic>
        <p:nvPicPr>
          <p:cNvPr id="7" name="Picture 6" descr="Chart, bar chart&#10;&#10;Description automatically generated">
            <a:extLst>
              <a:ext uri="{FF2B5EF4-FFF2-40B4-BE49-F238E27FC236}">
                <a16:creationId xmlns:a16="http://schemas.microsoft.com/office/drawing/2014/main" id="{9FACE932-CF0D-8344-4F3C-6ACBF5A2643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570" y="2320507"/>
            <a:ext cx="4623745" cy="1778626"/>
          </a:xfrm>
          <a:prstGeom prst="rect">
            <a:avLst/>
          </a:prstGeom>
        </p:spPr>
      </p:pic>
      <p:pic>
        <p:nvPicPr>
          <p:cNvPr id="11" name="Picture 10" descr="Chart, bar chart&#10;&#10;Description automatically generated">
            <a:extLst>
              <a:ext uri="{FF2B5EF4-FFF2-40B4-BE49-F238E27FC236}">
                <a16:creationId xmlns:a16="http://schemas.microsoft.com/office/drawing/2014/main" id="{98AB9D4F-FD1D-F4B6-3FCD-41B56AB7AFB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570" y="4127126"/>
            <a:ext cx="4623744" cy="252577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58B3159-60D3-21B1-5A11-4C04FD0F2CBE}"/>
              </a:ext>
            </a:extLst>
          </p:cNvPr>
          <p:cNvSpPr txBox="1"/>
          <p:nvPr/>
        </p:nvSpPr>
        <p:spPr>
          <a:xfrm>
            <a:off x="196248" y="6468234"/>
            <a:ext cx="34616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0" i="0" u="none" strike="noStrike" baseline="0" dirty="0">
                <a:latin typeface="LMRoman10-Regular"/>
              </a:rPr>
              <a:t>Supplementary Figure S3a, b, c</a:t>
            </a:r>
            <a:endParaRPr lang="en-GB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3308473-0BEF-52D9-51E8-135292262AB1}"/>
              </a:ext>
            </a:extLst>
          </p:cNvPr>
          <p:cNvSpPr txBox="1"/>
          <p:nvPr/>
        </p:nvSpPr>
        <p:spPr>
          <a:xfrm>
            <a:off x="3382653" y="1984737"/>
            <a:ext cx="5505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3F0B403-B919-A5E7-F03E-DEE52895FCDF}"/>
              </a:ext>
            </a:extLst>
          </p:cNvPr>
          <p:cNvSpPr txBox="1"/>
          <p:nvPr/>
        </p:nvSpPr>
        <p:spPr>
          <a:xfrm>
            <a:off x="3382653" y="3819349"/>
            <a:ext cx="5505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EC7BBD-D480-18D3-5C4D-CCB8470BF99C}"/>
              </a:ext>
            </a:extLst>
          </p:cNvPr>
          <p:cNvSpPr txBox="1"/>
          <p:nvPr/>
        </p:nvSpPr>
        <p:spPr>
          <a:xfrm>
            <a:off x="3382653" y="6345123"/>
            <a:ext cx="5505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16572966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diagram&#10;&#10;Description automatically generated">
            <a:extLst>
              <a:ext uri="{FF2B5EF4-FFF2-40B4-BE49-F238E27FC236}">
                <a16:creationId xmlns:a16="http://schemas.microsoft.com/office/drawing/2014/main" id="{A20B7FA2-BC0B-C298-237F-C9554C930C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6346" y="0"/>
            <a:ext cx="5905219" cy="68580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42283FCF-69FA-A3C7-3601-602D711E546D}"/>
              </a:ext>
            </a:extLst>
          </p:cNvPr>
          <p:cNvSpPr txBox="1"/>
          <p:nvPr/>
        </p:nvSpPr>
        <p:spPr>
          <a:xfrm>
            <a:off x="391886" y="6348888"/>
            <a:ext cx="275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0" i="0" u="none" strike="noStrike" baseline="0" dirty="0">
                <a:latin typeface="LMRoman10-Regular"/>
              </a:rPr>
              <a:t>Supplementary Figure S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474414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E8111157-F60D-B1C5-E1C2-525049A32C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959" y="531548"/>
            <a:ext cx="8864082" cy="1980171"/>
          </a:xfrm>
          <a:prstGeom prst="rect">
            <a:avLst/>
          </a:prstGeom>
        </p:spPr>
      </p:pic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3C9A177C-4472-4CCB-80E1-72931443EE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1661700"/>
              </p:ext>
            </p:extLst>
          </p:nvPr>
        </p:nvGraphicFramePr>
        <p:xfrm>
          <a:off x="2286000" y="283184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4EED55EE-9975-7ED7-AC86-36E564C159D6}"/>
              </a:ext>
            </a:extLst>
          </p:cNvPr>
          <p:cNvSpPr txBox="1"/>
          <p:nvPr/>
        </p:nvSpPr>
        <p:spPr>
          <a:xfrm>
            <a:off x="391884" y="6313200"/>
            <a:ext cx="30231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0" i="0" u="none" strike="noStrike" baseline="0" dirty="0">
                <a:latin typeface="LMRoman10-Regular"/>
              </a:rPr>
              <a:t>Supplementary Figure S5a, b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0199123-E0E1-8635-60DA-F829E3729F17}"/>
              </a:ext>
            </a:extLst>
          </p:cNvPr>
          <p:cNvSpPr txBox="1"/>
          <p:nvPr/>
        </p:nvSpPr>
        <p:spPr>
          <a:xfrm>
            <a:off x="139959" y="2216741"/>
            <a:ext cx="5505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1701192-806B-6507-535E-A7E35B755442}"/>
              </a:ext>
            </a:extLst>
          </p:cNvPr>
          <p:cNvSpPr txBox="1"/>
          <p:nvPr/>
        </p:nvSpPr>
        <p:spPr>
          <a:xfrm>
            <a:off x="2580219" y="5117067"/>
            <a:ext cx="5505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14044822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8A4A530D97B3A46A18BA386DCD47A7D" ma:contentTypeVersion="14" ma:contentTypeDescription="Create a new document." ma:contentTypeScope="" ma:versionID="e97ead6be6a72b63d2df511fd6ad8745">
  <xsd:schema xmlns:xsd="http://www.w3.org/2001/XMLSchema" xmlns:xs="http://www.w3.org/2001/XMLSchema" xmlns:p="http://schemas.microsoft.com/office/2006/metadata/properties" xmlns:ns3="f888d35b-2221-4bba-87d3-f75da9699220" xmlns:ns4="34fd0961-33cc-4ce0-8a0d-a99978c5e944" targetNamespace="http://schemas.microsoft.com/office/2006/metadata/properties" ma:root="true" ma:fieldsID="92500ab5fc642107271b20d236956378" ns3:_="" ns4:_="">
    <xsd:import namespace="f888d35b-2221-4bba-87d3-f75da9699220"/>
    <xsd:import namespace="34fd0961-33cc-4ce0-8a0d-a99978c5e944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OCR" minOccurs="0"/>
                <xsd:element ref="ns4:MediaServiceLocation" minOccurs="0"/>
                <xsd:element ref="ns4:MediaServiceGenerationTime" minOccurs="0"/>
                <xsd:element ref="ns4:MediaServiceEventHashCode" minOccurs="0"/>
                <xsd:element ref="ns4:MediaServiceAutoKeyPoints" minOccurs="0"/>
                <xsd:element ref="ns4:MediaServiceKeyPoints" minOccurs="0"/>
                <xsd:element ref="ns4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888d35b-2221-4bba-87d3-f75da9699220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4fd0961-33cc-4ce0-8a0d-a99978c5e94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4" nillable="true" ma:displayName="MediaServiceAutoTags" ma:description="" ma:internalName="MediaServiceAutoTags" ma:readOnly="true">
      <xsd:simpleType>
        <xsd:restriction base="dms:Text"/>
      </xsd:simpleType>
    </xsd:element>
    <xsd:element name="MediaServiceOCR" ma:index="15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6" nillable="true" ma:displayName="MediaServiceLocation" ma:internalName="MediaServiceLocation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8BA3B16-0E15-47F6-BBB6-06FBAC07362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3F6530D-E884-4892-990B-3D5FE77A17EA}">
  <ds:schemaRefs>
    <ds:schemaRef ds:uri="http://www.w3.org/XML/1998/namespace"/>
    <ds:schemaRef ds:uri="http://purl.org/dc/terms/"/>
    <ds:schemaRef ds:uri="http://purl.org/dc/dcmitype/"/>
    <ds:schemaRef ds:uri="http://schemas.openxmlformats.org/package/2006/metadata/core-properties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34fd0961-33cc-4ce0-8a0d-a99978c5e944"/>
    <ds:schemaRef ds:uri="f888d35b-2221-4bba-87d3-f75da9699220"/>
    <ds:schemaRef ds:uri="http://schemas.microsoft.com/office/2006/metadata/properties"/>
  </ds:schemaRefs>
</ds:datastoreItem>
</file>

<file path=customXml/itemProps3.xml><?xml version="1.0" encoding="utf-8"?>
<ds:datastoreItem xmlns:ds="http://schemas.openxmlformats.org/officeDocument/2006/customXml" ds:itemID="{A87BB69E-3F42-4EA6-8916-79A0FD9E3AA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888d35b-2221-4bba-87d3-f75da9699220"/>
    <ds:schemaRef ds:uri="34fd0961-33cc-4ce0-8a0d-a99978c5e94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64</TotalTime>
  <Words>51</Words>
  <Application>Microsoft Office PowerPoint</Application>
  <PresentationFormat>On-screen Show (4:3)</PresentationFormat>
  <Paragraphs>1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LMRoman10-Regular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dra Yadav [chy10]</dc:creator>
  <cp:lastModifiedBy>Chandra Yadav</cp:lastModifiedBy>
  <cp:revision>59</cp:revision>
  <cp:lastPrinted>2022-04-10T15:28:17Z</cp:lastPrinted>
  <dcterms:created xsi:type="dcterms:W3CDTF">2022-03-18T17:44:51Z</dcterms:created>
  <dcterms:modified xsi:type="dcterms:W3CDTF">2022-11-06T15:43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8A4A530D97B3A46A18BA386DCD47A7D</vt:lpwstr>
  </property>
</Properties>
</file>